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handoutMasterIdLst>
    <p:handoutMasterId r:id="rId6"/>
  </p:handoutMasterIdLst>
  <p:sldIdLst>
    <p:sldId id="505" r:id="rId2"/>
    <p:sldId id="499" r:id="rId3"/>
    <p:sldId id="500" r:id="rId4"/>
  </p:sldIdLst>
  <p:sldSz cx="12192000" cy="6858000"/>
  <p:notesSz cx="6807200" cy="99393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CC"/>
    <a:srgbClr val="FF00FF"/>
    <a:srgbClr val="3333FF"/>
    <a:srgbClr val="000066"/>
    <a:srgbClr val="00CCFF"/>
    <a:srgbClr val="66FF33"/>
    <a:srgbClr val="990033"/>
    <a:srgbClr val="A50021"/>
    <a:srgbClr val="006600"/>
    <a:srgbClr val="66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808" autoAdjust="0"/>
    <p:restoredTop sz="96357" autoAdjust="0"/>
  </p:normalViewPr>
  <p:slideViewPr>
    <p:cSldViewPr snapToGrid="0">
      <p:cViewPr varScale="1">
        <p:scale>
          <a:sx n="110" d="100"/>
          <a:sy n="110" d="100"/>
        </p:scale>
        <p:origin x="732" y="108"/>
      </p:cViewPr>
      <p:guideLst/>
    </p:cSldViewPr>
  </p:slideViewPr>
  <p:outlineViewPr>
    <p:cViewPr>
      <p:scale>
        <a:sx n="33" d="100"/>
        <a:sy n="33" d="100"/>
      </p:scale>
      <p:origin x="0" y="-8376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notesViewPr>
    <p:cSldViewPr snapToGrid="0">
      <p:cViewPr varScale="1">
        <p:scale>
          <a:sx n="50" d="100"/>
          <a:sy n="50" d="100"/>
        </p:scale>
        <p:origin x="2898" y="48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11" Type="http://schemas.microsoft.com/office/2016/11/relationships/changesInfo" Target="changesInfos/changesInfo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ifeng Peng" userId="977d67b5-6a2d-4389-a2d1-f7611f575af8" providerId="ADAL" clId="{0DBB4F28-967B-48CA-B2C2-9C807521A287}"/>
    <pc:docChg chg="modSld">
      <pc:chgData name="Lifeng Peng" userId="977d67b5-6a2d-4389-a2d1-f7611f575af8" providerId="ADAL" clId="{0DBB4F28-967B-48CA-B2C2-9C807521A287}" dt="2022-06-06T22:21:29.760" v="2" actId="20577"/>
      <pc:docMkLst>
        <pc:docMk/>
      </pc:docMkLst>
      <pc:sldChg chg="modSp mod">
        <pc:chgData name="Lifeng Peng" userId="977d67b5-6a2d-4389-a2d1-f7611f575af8" providerId="ADAL" clId="{0DBB4F28-967B-48CA-B2C2-9C807521A287}" dt="2022-06-06T22:21:26.943" v="1" actId="20577"/>
        <pc:sldMkLst>
          <pc:docMk/>
          <pc:sldMk cId="926368468" sldId="499"/>
        </pc:sldMkLst>
        <pc:spChg chg="mod">
          <ac:chgData name="Lifeng Peng" userId="977d67b5-6a2d-4389-a2d1-f7611f575af8" providerId="ADAL" clId="{0DBB4F28-967B-48CA-B2C2-9C807521A287}" dt="2022-06-06T22:21:26.943" v="1" actId="20577"/>
          <ac:spMkLst>
            <pc:docMk/>
            <pc:sldMk cId="926368468" sldId="499"/>
            <ac:spMk id="7" creationId="{91A046DF-BFBC-4115-93DA-69C9A0474087}"/>
          </ac:spMkLst>
        </pc:spChg>
      </pc:sldChg>
      <pc:sldChg chg="modSp mod">
        <pc:chgData name="Lifeng Peng" userId="977d67b5-6a2d-4389-a2d1-f7611f575af8" providerId="ADAL" clId="{0DBB4F28-967B-48CA-B2C2-9C807521A287}" dt="2022-06-06T22:21:29.760" v="2" actId="20577"/>
        <pc:sldMkLst>
          <pc:docMk/>
          <pc:sldMk cId="3086607569" sldId="500"/>
        </pc:sldMkLst>
        <pc:spChg chg="mod">
          <ac:chgData name="Lifeng Peng" userId="977d67b5-6a2d-4389-a2d1-f7611f575af8" providerId="ADAL" clId="{0DBB4F28-967B-48CA-B2C2-9C807521A287}" dt="2022-06-06T22:21:29.760" v="2" actId="20577"/>
          <ac:spMkLst>
            <pc:docMk/>
            <pc:sldMk cId="3086607569" sldId="500"/>
            <ac:spMk id="4" creationId="{86F3EF7A-E79A-4E39-8DB0-7198EC183B96}"/>
          </ac:spMkLst>
        </pc:spChg>
      </pc:sldChg>
      <pc:sldChg chg="modSp mod">
        <pc:chgData name="Lifeng Peng" userId="977d67b5-6a2d-4389-a2d1-f7611f575af8" providerId="ADAL" clId="{0DBB4F28-967B-48CA-B2C2-9C807521A287}" dt="2022-06-06T22:21:24.396" v="0" actId="20577"/>
        <pc:sldMkLst>
          <pc:docMk/>
          <pc:sldMk cId="3557997074" sldId="505"/>
        </pc:sldMkLst>
        <pc:spChg chg="mod">
          <ac:chgData name="Lifeng Peng" userId="977d67b5-6a2d-4389-a2d1-f7611f575af8" providerId="ADAL" clId="{0DBB4F28-967B-48CA-B2C2-9C807521A287}" dt="2022-06-06T22:21:24.396" v="0" actId="20577"/>
          <ac:spMkLst>
            <pc:docMk/>
            <pc:sldMk cId="3557997074" sldId="505"/>
            <ac:spMk id="4" creationId="{B3006CA5-50B3-4F0F-AA3A-CA5C998E200A}"/>
          </ac:spMkLst>
        </pc:spChg>
      </pc:sldChg>
    </pc:docChg>
  </pc:docChgLst>
  <pc:docChgLst>
    <pc:chgData name="Lifeng Peng" userId="977d67b5-6a2d-4389-a2d1-f7611f575af8" providerId="ADAL" clId="{622236FC-3CF8-4297-9F71-A318A4D02FDA}"/>
    <pc:docChg chg="addSld delSld modSld">
      <pc:chgData name="Lifeng Peng" userId="977d67b5-6a2d-4389-a2d1-f7611f575af8" providerId="ADAL" clId="{622236FC-3CF8-4297-9F71-A318A4D02FDA}" dt="2022-03-04T22:48:12.245" v="9" actId="47"/>
      <pc:docMkLst>
        <pc:docMk/>
      </pc:docMkLst>
      <pc:sldChg chg="del">
        <pc:chgData name="Lifeng Peng" userId="977d67b5-6a2d-4389-a2d1-f7611f575af8" providerId="ADAL" clId="{622236FC-3CF8-4297-9F71-A318A4D02FDA}" dt="2022-03-04T22:48:12.245" v="9" actId="47"/>
        <pc:sldMkLst>
          <pc:docMk/>
          <pc:sldMk cId="4281938686" sldId="501"/>
        </pc:sldMkLst>
      </pc:sldChg>
      <pc:sldChg chg="del">
        <pc:chgData name="Lifeng Peng" userId="977d67b5-6a2d-4389-a2d1-f7611f575af8" providerId="ADAL" clId="{622236FC-3CF8-4297-9F71-A318A4D02FDA}" dt="2022-03-04T22:48:12.245" v="9" actId="47"/>
        <pc:sldMkLst>
          <pc:docMk/>
          <pc:sldMk cId="2958194408" sldId="502"/>
        </pc:sldMkLst>
      </pc:sldChg>
      <pc:sldChg chg="del">
        <pc:chgData name="Lifeng Peng" userId="977d67b5-6a2d-4389-a2d1-f7611f575af8" providerId="ADAL" clId="{622236FC-3CF8-4297-9F71-A318A4D02FDA}" dt="2022-03-04T22:48:12.245" v="9" actId="47"/>
        <pc:sldMkLst>
          <pc:docMk/>
          <pc:sldMk cId="565510306" sldId="503"/>
        </pc:sldMkLst>
      </pc:sldChg>
      <pc:sldChg chg="del">
        <pc:chgData name="Lifeng Peng" userId="977d67b5-6a2d-4389-a2d1-f7611f575af8" providerId="ADAL" clId="{622236FC-3CF8-4297-9F71-A318A4D02FDA}" dt="2022-03-04T22:48:12.245" v="9" actId="47"/>
        <pc:sldMkLst>
          <pc:docMk/>
          <pc:sldMk cId="3089828148" sldId="504"/>
        </pc:sldMkLst>
      </pc:sldChg>
      <pc:sldChg chg="modSp mod">
        <pc:chgData name="Lifeng Peng" userId="977d67b5-6a2d-4389-a2d1-f7611f575af8" providerId="ADAL" clId="{622236FC-3CF8-4297-9F71-A318A4D02FDA}" dt="2022-03-04T21:34:00.415" v="2" actId="6549"/>
        <pc:sldMkLst>
          <pc:docMk/>
          <pc:sldMk cId="3557997074" sldId="505"/>
        </pc:sldMkLst>
        <pc:spChg chg="mod">
          <ac:chgData name="Lifeng Peng" userId="977d67b5-6a2d-4389-a2d1-f7611f575af8" providerId="ADAL" clId="{622236FC-3CF8-4297-9F71-A318A4D02FDA}" dt="2022-03-04T21:34:00.415" v="2" actId="6549"/>
          <ac:spMkLst>
            <pc:docMk/>
            <pc:sldMk cId="3557997074" sldId="505"/>
            <ac:spMk id="4" creationId="{B3006CA5-50B3-4F0F-AA3A-CA5C998E200A}"/>
          </ac:spMkLst>
        </pc:spChg>
      </pc:sldChg>
      <pc:sldChg chg="modSp add del mod">
        <pc:chgData name="Lifeng Peng" userId="977d67b5-6a2d-4389-a2d1-f7611f575af8" providerId="ADAL" clId="{622236FC-3CF8-4297-9F71-A318A4D02FDA}" dt="2022-03-04T22:48:12.245" v="9" actId="47"/>
        <pc:sldMkLst>
          <pc:docMk/>
          <pc:sldMk cId="3470445632" sldId="506"/>
        </pc:sldMkLst>
        <pc:spChg chg="mod">
          <ac:chgData name="Lifeng Peng" userId="977d67b5-6a2d-4389-a2d1-f7611f575af8" providerId="ADAL" clId="{622236FC-3CF8-4297-9F71-A318A4D02FDA}" dt="2022-03-04T21:34:34.402" v="6" actId="6549"/>
          <ac:spMkLst>
            <pc:docMk/>
            <pc:sldMk cId="3470445632" sldId="506"/>
            <ac:spMk id="4" creationId="{B3006CA5-50B3-4F0F-AA3A-CA5C998E200A}"/>
          </ac:spMkLst>
        </pc:spChg>
      </pc:sldChg>
      <pc:sldChg chg="modSp add del mod">
        <pc:chgData name="Lifeng Peng" userId="977d67b5-6a2d-4389-a2d1-f7611f575af8" providerId="ADAL" clId="{622236FC-3CF8-4297-9F71-A318A4D02FDA}" dt="2022-03-04T22:48:12.245" v="9" actId="47"/>
        <pc:sldMkLst>
          <pc:docMk/>
          <pc:sldMk cId="709091179" sldId="507"/>
        </pc:sldMkLst>
        <pc:spChg chg="mod">
          <ac:chgData name="Lifeng Peng" userId="977d67b5-6a2d-4389-a2d1-f7611f575af8" providerId="ADAL" clId="{622236FC-3CF8-4297-9F71-A318A4D02FDA}" dt="2022-03-04T21:34:52.474" v="8" actId="6549"/>
          <ac:spMkLst>
            <pc:docMk/>
            <pc:sldMk cId="709091179" sldId="507"/>
            <ac:spMk id="4" creationId="{B3006CA5-50B3-4F0F-AA3A-CA5C998E200A}"/>
          </ac:spMkLst>
        </pc:spChg>
      </pc:sldChg>
    </pc:docChg>
  </pc:docChgLst>
  <pc:docChgLst>
    <pc:chgData name="Lifeng Peng" userId="977d67b5-6a2d-4389-a2d1-f7611f575af8" providerId="ADAL" clId="{B4BF171F-E198-45A8-808D-2750A4473864}"/>
    <pc:docChg chg="custSel addSld modSld">
      <pc:chgData name="Lifeng Peng" userId="977d67b5-6a2d-4389-a2d1-f7611f575af8" providerId="ADAL" clId="{B4BF171F-E198-45A8-808D-2750A4473864}" dt="2021-10-09T17:47:23.690" v="6" actId="14100"/>
      <pc:docMkLst>
        <pc:docMk/>
      </pc:docMkLst>
      <pc:sldChg chg="addSp delSp modSp new mod">
        <pc:chgData name="Lifeng Peng" userId="977d67b5-6a2d-4389-a2d1-f7611f575af8" providerId="ADAL" clId="{B4BF171F-E198-45A8-808D-2750A4473864}" dt="2021-10-09T17:47:23.690" v="6" actId="14100"/>
        <pc:sldMkLst>
          <pc:docMk/>
          <pc:sldMk cId="3329700708" sldId="576"/>
        </pc:sldMkLst>
        <pc:spChg chg="del">
          <ac:chgData name="Lifeng Peng" userId="977d67b5-6a2d-4389-a2d1-f7611f575af8" providerId="ADAL" clId="{B4BF171F-E198-45A8-808D-2750A4473864}" dt="2021-10-09T17:47:13.654" v="1" actId="478"/>
          <ac:spMkLst>
            <pc:docMk/>
            <pc:sldMk cId="3329700708" sldId="576"/>
            <ac:spMk id="2" creationId="{F66698FE-6578-4945-9463-486792DCF1EF}"/>
          </ac:spMkLst>
        </pc:spChg>
        <pc:picChg chg="add mod">
          <ac:chgData name="Lifeng Peng" userId="977d67b5-6a2d-4389-a2d1-f7611f575af8" providerId="ADAL" clId="{B4BF171F-E198-45A8-808D-2750A4473864}" dt="2021-10-09T17:47:23.690" v="6" actId="14100"/>
          <ac:picMkLst>
            <pc:docMk/>
            <pc:sldMk cId="3329700708" sldId="576"/>
            <ac:picMk id="4" creationId="{D0FDC36C-F9A6-4E23-96C3-E4297A424422}"/>
          </ac:picMkLst>
        </pc:picChg>
      </pc:sldChg>
    </pc:docChg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2"/>
            <a:ext cx="2949787" cy="498694"/>
          </a:xfrm>
          <a:prstGeom prst="rect">
            <a:avLst/>
          </a:prstGeom>
        </p:spPr>
        <p:txBody>
          <a:bodyPr vert="horz" lIns="91421" tIns="45710" rIns="91421" bIns="45710" rtlCol="0"/>
          <a:lstStyle>
            <a:lvl1pPr algn="l">
              <a:defRPr sz="1200"/>
            </a:lvl1pPr>
          </a:lstStyle>
          <a:p>
            <a:endParaRPr lang="en-NZ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5842" y="2"/>
            <a:ext cx="2949787" cy="498694"/>
          </a:xfrm>
          <a:prstGeom prst="rect">
            <a:avLst/>
          </a:prstGeom>
        </p:spPr>
        <p:txBody>
          <a:bodyPr vert="horz" lIns="91421" tIns="45710" rIns="91421" bIns="45710" rtlCol="0"/>
          <a:lstStyle>
            <a:lvl1pPr algn="r">
              <a:defRPr sz="1200"/>
            </a:lvl1pPr>
          </a:lstStyle>
          <a:p>
            <a:fld id="{B189384C-AFAE-415D-BAFB-C047AD5846B6}" type="datetimeFigureOut">
              <a:rPr lang="en-NZ" smtClean="0"/>
              <a:t>7/06/2022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2" y="9440649"/>
            <a:ext cx="2949787" cy="498691"/>
          </a:xfrm>
          <a:prstGeom prst="rect">
            <a:avLst/>
          </a:prstGeom>
        </p:spPr>
        <p:txBody>
          <a:bodyPr vert="horz" lIns="91421" tIns="45710" rIns="91421" bIns="45710" rtlCol="0" anchor="b"/>
          <a:lstStyle>
            <a:lvl1pPr algn="l">
              <a:defRPr sz="1200"/>
            </a:lvl1pPr>
          </a:lstStyle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5842" y="9440649"/>
            <a:ext cx="2949787" cy="498691"/>
          </a:xfrm>
          <a:prstGeom prst="rect">
            <a:avLst/>
          </a:prstGeom>
        </p:spPr>
        <p:txBody>
          <a:bodyPr vert="horz" lIns="91421" tIns="45710" rIns="91421" bIns="45710" rtlCol="0" anchor="b"/>
          <a:lstStyle>
            <a:lvl1pPr algn="r">
              <a:defRPr sz="1200"/>
            </a:lvl1pPr>
          </a:lstStyle>
          <a:p>
            <a:fld id="{867174E1-5D42-4826-87CB-0C3147E5624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01785647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2"/>
            <a:ext cx="2949787" cy="498694"/>
          </a:xfrm>
          <a:prstGeom prst="rect">
            <a:avLst/>
          </a:prstGeom>
        </p:spPr>
        <p:txBody>
          <a:bodyPr vert="horz" lIns="91421" tIns="45710" rIns="91421" bIns="4571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5842" y="2"/>
            <a:ext cx="2949787" cy="498694"/>
          </a:xfrm>
          <a:prstGeom prst="rect">
            <a:avLst/>
          </a:prstGeom>
        </p:spPr>
        <p:txBody>
          <a:bodyPr vert="horz" lIns="91421" tIns="45710" rIns="91421" bIns="45710" rtlCol="0"/>
          <a:lstStyle>
            <a:lvl1pPr algn="r">
              <a:defRPr sz="1200"/>
            </a:lvl1pPr>
          </a:lstStyle>
          <a:p>
            <a:fld id="{392ABA83-70EF-4BEB-98AD-CB1BA412F4CD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23863" y="1243013"/>
            <a:ext cx="5959475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1" tIns="45710" rIns="91421" bIns="4571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720" y="4783309"/>
            <a:ext cx="5445760" cy="3913615"/>
          </a:xfrm>
          <a:prstGeom prst="rect">
            <a:avLst/>
          </a:prstGeom>
        </p:spPr>
        <p:txBody>
          <a:bodyPr vert="horz" lIns="91421" tIns="45710" rIns="91421" bIns="4571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9440649"/>
            <a:ext cx="2949787" cy="498691"/>
          </a:xfrm>
          <a:prstGeom prst="rect">
            <a:avLst/>
          </a:prstGeom>
        </p:spPr>
        <p:txBody>
          <a:bodyPr vert="horz" lIns="91421" tIns="45710" rIns="91421" bIns="4571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5842" y="9440649"/>
            <a:ext cx="2949787" cy="498691"/>
          </a:xfrm>
          <a:prstGeom prst="rect">
            <a:avLst/>
          </a:prstGeom>
        </p:spPr>
        <p:txBody>
          <a:bodyPr vert="horz" lIns="91421" tIns="45710" rIns="91421" bIns="45710" rtlCol="0" anchor="b"/>
          <a:lstStyle>
            <a:lvl1pPr algn="r">
              <a:defRPr sz="1200"/>
            </a:lvl1pPr>
          </a:lstStyle>
          <a:p>
            <a:fld id="{7E24DD7F-04EE-4BC3-84CB-E1B412AB7AC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053473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701689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475469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317799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774494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70815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77418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685500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796634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569834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928269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726592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369205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3006CA5-50B3-4F0F-AA3A-CA5C998E200A}"/>
              </a:ext>
            </a:extLst>
          </p:cNvPr>
          <p:cNvSpPr/>
          <p:nvPr/>
        </p:nvSpPr>
        <p:spPr>
          <a:xfrm>
            <a:off x="470262" y="358567"/>
            <a:ext cx="11190515" cy="39628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NZ" sz="1600" b="1" dirty="0">
                <a:ea typeface="Calibri" panose="020F0502020204030204" pitchFamily="34" charset="0"/>
                <a:cs typeface="Times New Roman" panose="02020603050405020304" pitchFamily="18" charset="0"/>
              </a:rPr>
              <a:t>Additional File 9: Analysis of proteins with significantly differential expression in LGCA tissues compared to NC tissues. </a:t>
            </a:r>
          </a:p>
          <a:p>
            <a:pPr>
              <a:lnSpc>
                <a:spcPct val="200000"/>
              </a:lnSpc>
            </a:pPr>
            <a:r>
              <a:rPr lang="en-NZ" sz="1600" b="1" dirty="0">
                <a:ea typeface="Calibri" panose="020F0502020204030204" pitchFamily="34" charset="0"/>
                <a:cs typeface="Times New Roman" panose="02020603050405020304" pitchFamily="18" charset="0"/>
              </a:rPr>
              <a:t>A, </a:t>
            </a:r>
            <a:r>
              <a:rPr lang="en-NZ" sz="1600" dirty="0">
                <a:ea typeface="Calibri" panose="020F0502020204030204" pitchFamily="34" charset="0"/>
                <a:cs typeface="Times New Roman" panose="02020603050405020304" pitchFamily="18" charset="0"/>
              </a:rPr>
              <a:t>Proteins with significantly increased abundance</a:t>
            </a:r>
            <a:r>
              <a:rPr lang="en-NZ" sz="1600" dirty="0">
                <a:ea typeface="Calibri" panose="020F0502020204030204" pitchFamily="34" charset="0"/>
                <a:cs typeface="Calibri" panose="020F0502020204030204" pitchFamily="34" charset="0"/>
              </a:rPr>
              <a:t> with a moderate confidence level (0.4)</a:t>
            </a:r>
            <a:r>
              <a:rPr lang="en-NZ" sz="1600" dirty="0">
                <a:ea typeface="Calibri" panose="020F0502020204030204" pitchFamily="34" charset="0"/>
                <a:cs typeface="Times New Roman" panose="02020603050405020304" pitchFamily="18" charset="0"/>
              </a:rPr>
              <a:t>, with GO terms or KEGG or </a:t>
            </a:r>
            <a:r>
              <a:rPr lang="en-NZ" sz="1600" dirty="0" err="1">
                <a:ea typeface="Calibri" panose="020F0502020204030204" pitchFamily="34" charset="0"/>
                <a:cs typeface="Times New Roman" panose="02020603050405020304" pitchFamily="18" charset="0"/>
              </a:rPr>
              <a:t>Reactome</a:t>
            </a:r>
            <a:r>
              <a:rPr lang="en-NZ" sz="1600" dirty="0">
                <a:ea typeface="Calibri" panose="020F0502020204030204" pitchFamily="34" charset="0"/>
                <a:cs typeface="Times New Roman" panose="02020603050405020304" pitchFamily="18" charset="0"/>
              </a:rPr>
              <a:t> pathways of interest coloured as follows: Red – sterol biosynthesis; Blue – cholesterol biosynthesis; Green – exosome (</a:t>
            </a:r>
            <a:r>
              <a:rPr lang="en-NZ" sz="1600" dirty="0" err="1">
                <a:ea typeface="Calibri" panose="020F0502020204030204" pitchFamily="34" charset="0"/>
                <a:cs typeface="Times New Roman" panose="02020603050405020304" pitchFamily="18" charset="0"/>
              </a:rPr>
              <a:t>rnase</a:t>
            </a:r>
            <a:r>
              <a:rPr lang="en-NZ" sz="1600" dirty="0">
                <a:ea typeface="Calibri" panose="020F0502020204030204" pitchFamily="34" charset="0"/>
                <a:cs typeface="Times New Roman" panose="02020603050405020304" pitchFamily="18" charset="0"/>
              </a:rPr>
              <a:t> complex); Yellow – </a:t>
            </a:r>
            <a:r>
              <a:rPr lang="en-NZ" sz="1600" dirty="0" err="1">
                <a:ea typeface="Calibri" panose="020F0502020204030204" pitchFamily="34" charset="0"/>
                <a:cs typeface="Times New Roman" panose="02020603050405020304" pitchFamily="18" charset="0"/>
              </a:rPr>
              <a:t>preribosome</a:t>
            </a:r>
            <a:r>
              <a:rPr lang="en-NZ" sz="1600" dirty="0"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NZ" sz="1600" b="1" dirty="0">
                <a:ea typeface="Calibri" panose="020F0502020204030204" pitchFamily="34" charset="0"/>
                <a:cs typeface="Times New Roman" panose="02020603050405020304" pitchFamily="18" charset="0"/>
              </a:rPr>
              <a:t> B, </a:t>
            </a:r>
            <a:r>
              <a:rPr lang="en-NZ" sz="1600" dirty="0">
                <a:ea typeface="Calibri" panose="020F0502020204030204" pitchFamily="34" charset="0"/>
                <a:cs typeface="Times New Roman" panose="02020603050405020304" pitchFamily="18" charset="0"/>
              </a:rPr>
              <a:t>Proteins with significantly decreased abundance</a:t>
            </a:r>
            <a:r>
              <a:rPr lang="en-NZ" sz="1600" dirty="0">
                <a:ea typeface="Calibri" panose="020F0502020204030204" pitchFamily="34" charset="0"/>
                <a:cs typeface="Calibri" panose="020F0502020204030204" pitchFamily="34" charset="0"/>
              </a:rPr>
              <a:t> with a moderate confidence level (0.4)</a:t>
            </a:r>
            <a:r>
              <a:rPr lang="en-NZ" sz="1600" dirty="0">
                <a:ea typeface="Calibri" panose="020F0502020204030204" pitchFamily="34" charset="0"/>
                <a:cs typeface="Times New Roman" panose="02020603050405020304" pitchFamily="18" charset="0"/>
              </a:rPr>
              <a:t>, with GO terms or KEGG or </a:t>
            </a:r>
            <a:r>
              <a:rPr lang="en-NZ" sz="1600" dirty="0" err="1">
                <a:ea typeface="Calibri" panose="020F0502020204030204" pitchFamily="34" charset="0"/>
                <a:cs typeface="Times New Roman" panose="02020603050405020304" pitchFamily="18" charset="0"/>
              </a:rPr>
              <a:t>Reactome</a:t>
            </a:r>
            <a:r>
              <a:rPr lang="en-NZ" sz="1600" dirty="0">
                <a:ea typeface="Calibri" panose="020F0502020204030204" pitchFamily="34" charset="0"/>
                <a:cs typeface="Times New Roman" panose="02020603050405020304" pitchFamily="18" charset="0"/>
              </a:rPr>
              <a:t> pathways of interest coloured as follows: Red – regulation of cytoskeleton organization; Blue – cellular component assembly involved in morphogenesis; Light Green – muscle system process; Yellow – caveolar macromolecular signalling complex; Pink – cytoskeleton organization; Dark Green – myofibril assembly; Teal – actin-mediated cell contraction; Orange – plasma membrane organization; Purple – actomyosin structure organization; Brown – cellular component morphogenesis.</a:t>
            </a:r>
            <a:r>
              <a:rPr lang="en-NZ" sz="1600" b="1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5579970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A picture containing diagram&#10;&#10;Description automatically generated">
            <a:extLst>
              <a:ext uri="{FF2B5EF4-FFF2-40B4-BE49-F238E27FC236}">
                <a16:creationId xmlns:a16="http://schemas.microsoft.com/office/drawing/2014/main" id="{8B428DF5-7035-4C46-84AF-4D9EAB722D6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8943" y="0"/>
            <a:ext cx="9394113" cy="68580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91A046DF-BFBC-4115-93DA-69C9A0474087}"/>
              </a:ext>
            </a:extLst>
          </p:cNvPr>
          <p:cNvSpPr txBox="1"/>
          <p:nvPr/>
        </p:nvSpPr>
        <p:spPr>
          <a:xfrm>
            <a:off x="407406" y="126749"/>
            <a:ext cx="19012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dirty="0"/>
              <a:t>Additional File 9A</a:t>
            </a:r>
          </a:p>
        </p:txBody>
      </p:sp>
    </p:spTree>
    <p:extLst>
      <p:ext uri="{BB962C8B-B14F-4D97-AF65-F5344CB8AC3E}">
        <p14:creationId xmlns:p14="http://schemas.microsoft.com/office/powerpoint/2010/main" val="9263684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6F3EF7A-E79A-4E39-8DB0-7198EC183B96}"/>
              </a:ext>
            </a:extLst>
          </p:cNvPr>
          <p:cNvSpPr txBox="1"/>
          <p:nvPr/>
        </p:nvSpPr>
        <p:spPr>
          <a:xfrm>
            <a:off x="407406" y="126749"/>
            <a:ext cx="19012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dirty="0"/>
              <a:t>Additional File 9B</a:t>
            </a:r>
          </a:p>
        </p:txBody>
      </p:sp>
      <p:pic>
        <p:nvPicPr>
          <p:cNvPr id="6" name="Picture 5" descr="Background pattern&#10;&#10;Description automatically generated">
            <a:extLst>
              <a:ext uri="{FF2B5EF4-FFF2-40B4-BE49-F238E27FC236}">
                <a16:creationId xmlns:a16="http://schemas.microsoft.com/office/drawing/2014/main" id="{EA7E357F-0D22-4E84-8BEF-3BF88B1F81A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9506" y="0"/>
            <a:ext cx="549298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866075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80</TotalTime>
  <Words>169</Words>
  <Application>Microsoft Office PowerPoint</Application>
  <PresentationFormat>Widescreen</PresentationFormat>
  <Paragraphs>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feng Peng</dc:creator>
  <cp:lastModifiedBy>Lifeng Peng</cp:lastModifiedBy>
  <cp:revision>1150</cp:revision>
  <cp:lastPrinted>2019-05-17T00:46:07Z</cp:lastPrinted>
  <dcterms:created xsi:type="dcterms:W3CDTF">2014-04-18T17:12:37Z</dcterms:created>
  <dcterms:modified xsi:type="dcterms:W3CDTF">2022-06-06T22:21:32Z</dcterms:modified>
</cp:coreProperties>
</file>